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72824-D154-48B3-9968-45088418C1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4BAA3-1E8E-4FE0-93EF-D9DFC790BA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322BE-8D43-4DCF-908B-8D69AEDB26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19A75-406C-4C2E-89E6-87B1A6C059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ABADE-C6C5-4009-9139-F056BC248A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8890B-16D3-44AD-99F9-64978A1B8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9FDC7-017D-459C-8707-3A8BE52537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EFF9C-AD3D-43F4-BA46-5C9ED7A0B8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85A15-9244-4D36-B499-060338A592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CAA01-5F71-487A-80AA-189EF89AB9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8666B-0B03-4399-B365-9638093727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73320-6CCB-480B-9D42-E9E2F5B21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3BEDB7-53C7-45DD-958C-A03D5DB10C2C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A24A7A-9326-4DDD-ACEB-F237B8122BA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28600" y="990720"/>
          <a:ext cx="6019920" cy="6781680"/>
        </p:xfrm>
        <a:graphic>
          <a:graphicData uri="http://schemas.openxmlformats.org/drawingml/2006/table">
            <a:tbl>
              <a:tblPr/>
              <a:tblGrid>
                <a:gridCol w="2438280"/>
                <a:gridCol w="1828800"/>
                <a:gridCol w="1752840"/>
              </a:tblGrid>
              <a:tr h="67140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emical Structur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emBridge ID 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ame used in text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bChem ID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2724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828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Geneva"/>
                        </a:rPr>
                        <a:t>(C834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958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2688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7037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(C755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041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2724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556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(C103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839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0168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384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(C410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371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27240"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Cambria"/>
                        </a:rPr>
                        <a:t>52625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13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(C578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4360" rIns="54360" tIns="24120" bIns="241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2007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360" marR="54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pSp>
        <p:nvGrpSpPr>
          <p:cNvPr id="42" name="Group 10"/>
          <p:cNvGrpSpPr/>
          <p:nvPr/>
        </p:nvGrpSpPr>
        <p:grpSpPr>
          <a:xfrm>
            <a:off x="341280" y="1839960"/>
            <a:ext cx="2103480" cy="5613480"/>
            <a:chOff x="341280" y="1839960"/>
            <a:chExt cx="2103480" cy="5613480"/>
          </a:xfrm>
        </p:grpSpPr>
        <p:pic>
          <p:nvPicPr>
            <p:cNvPr id="43" name="Picture 4" descr="C755"/>
            <p:cNvPicPr/>
            <p:nvPr/>
          </p:nvPicPr>
          <p:blipFill>
            <a:blip r:embed="rId1"/>
            <a:stretch/>
          </p:blipFill>
          <p:spPr>
            <a:xfrm>
              <a:off x="352800" y="3044880"/>
              <a:ext cx="2091960" cy="1009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C103 structure"/>
            <p:cNvPicPr/>
            <p:nvPr/>
          </p:nvPicPr>
          <p:blipFill>
            <a:blip r:embed="rId2"/>
            <a:stretch/>
          </p:blipFill>
          <p:spPr>
            <a:xfrm>
              <a:off x="552600" y="4154760"/>
              <a:ext cx="1517400" cy="1314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4" descr="C578 structure"/>
            <p:cNvPicPr/>
            <p:nvPr/>
          </p:nvPicPr>
          <p:blipFill>
            <a:blip r:embed="rId3"/>
            <a:stretch/>
          </p:blipFill>
          <p:spPr>
            <a:xfrm>
              <a:off x="391680" y="6718680"/>
              <a:ext cx="2004120" cy="734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4" descr="C8410"/>
            <p:cNvPicPr/>
            <p:nvPr/>
          </p:nvPicPr>
          <p:blipFill>
            <a:blip r:embed="rId4"/>
            <a:stretch/>
          </p:blipFill>
          <p:spPr>
            <a:xfrm>
              <a:off x="352800" y="5345280"/>
              <a:ext cx="1891440" cy="138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5" descr="C834structure"/>
            <p:cNvPicPr/>
            <p:nvPr/>
          </p:nvPicPr>
          <p:blipFill>
            <a:blip r:embed="rId5"/>
            <a:stretch/>
          </p:blipFill>
          <p:spPr>
            <a:xfrm>
              <a:off x="341280" y="1839960"/>
              <a:ext cx="1852560" cy="1213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8" name="TextBox 11"/>
          <p:cNvSpPr/>
          <p:nvPr/>
        </p:nvSpPr>
        <p:spPr>
          <a:xfrm>
            <a:off x="228600" y="304920"/>
            <a:ext cx="6019920" cy="69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760" rIns="50760" tIns="25560" bIns="255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. Chemical structure, and Chembridge and PubChem ID numbers for  the tonoplast trafficking inhibitors.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ort name in parenthesis is used in the tex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2T14:54:21Z</dcterms:created>
  <dc:creator>lab</dc:creator>
  <dc:description/>
  <dc:language>en-US</dc:language>
  <cp:lastModifiedBy>Marcela Pierce</cp:lastModifiedBy>
  <cp:lastPrinted>2012-02-01T20:09:31Z</cp:lastPrinted>
  <dcterms:modified xsi:type="dcterms:W3CDTF">2012-08-13T18:31:09Z</dcterms:modified>
  <cp:revision>23</cp:revision>
  <dc:subject/>
  <dc:title>PowerPoint Presentation</dc:title>
</cp:coreProperties>
</file>